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57" r:id="rId2"/>
    <p:sldId id="258" r:id="rId3"/>
    <p:sldId id="262" r:id="rId4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468"/>
    <p:restoredTop sz="94624"/>
  </p:normalViewPr>
  <p:slideViewPr>
    <p:cSldViewPr snapToGrid="0" snapToObjects="1">
      <p:cViewPr>
        <p:scale>
          <a:sx n="100" d="100"/>
          <a:sy n="100" d="100"/>
        </p:scale>
        <p:origin x="160" y="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 dirty="0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9CBA96-461A-E747-A098-B8B6A41677E0}" type="datetimeFigureOut">
              <a:rPr lang="nl-NL" smtClean="0"/>
              <a:t>20-06-21</a:t>
            </a:fld>
            <a:endParaRPr lang="nl-NL" dirty="0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 dirty="0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 smtClean="0"/>
              <a:t>Klik om de tekststijl van het model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 dirty="0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115CBB-05EF-F841-AF8E-03ED6F06B6D5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5584314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 smtClean="0"/>
              <a:t>Titelstijl van model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 smtClean="0"/>
              <a:t>Klik om de ondertitelstijl van het mod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18BEA-610E-C84A-9896-74B1099551D5}" type="datetimeFigureOut">
              <a:rPr lang="nl-NL" smtClean="0"/>
              <a:t>20-06-21</a:t>
            </a:fld>
            <a:endParaRPr lang="nl-NL" dirty="0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37E4B-4F1E-3043-A89A-4B5794CD3DCA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402947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Titelstijl van model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tekststijl van het model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18BEA-610E-C84A-9896-74B1099551D5}" type="datetimeFigureOut">
              <a:rPr lang="nl-NL" smtClean="0"/>
              <a:t>20-06-21</a:t>
            </a:fld>
            <a:endParaRPr lang="nl-NL" dirty="0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37E4B-4F1E-3043-A89A-4B5794CD3DCA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117671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 smtClean="0"/>
              <a:t>Titelstijl van model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 smtClean="0"/>
              <a:t>Klik om de tekststijl van het model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18BEA-610E-C84A-9896-74B1099551D5}" type="datetimeFigureOut">
              <a:rPr lang="nl-NL" smtClean="0"/>
              <a:t>20-06-21</a:t>
            </a:fld>
            <a:endParaRPr lang="nl-NL" dirty="0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37E4B-4F1E-3043-A89A-4B5794CD3DCA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4578473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Titelstijl van model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tekststijl van het model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18BEA-610E-C84A-9896-74B1099551D5}" type="datetimeFigureOut">
              <a:rPr lang="nl-NL" smtClean="0"/>
              <a:t>20-06-21</a:t>
            </a:fld>
            <a:endParaRPr lang="nl-NL" dirty="0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37E4B-4F1E-3043-A89A-4B5794CD3DCA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3242397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 smtClean="0"/>
              <a:t>Titelstijl van model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tekststijl van het model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18BEA-610E-C84A-9896-74B1099551D5}" type="datetimeFigureOut">
              <a:rPr lang="nl-NL" smtClean="0"/>
              <a:t>20-06-21</a:t>
            </a:fld>
            <a:endParaRPr lang="nl-NL" dirty="0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37E4B-4F1E-3043-A89A-4B5794CD3DCA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1244948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ee objecte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Titelstijl van model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 smtClean="0"/>
              <a:t>Klik om de tekststijl van het model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 smtClean="0"/>
              <a:t>Klik om de tekststijl van het model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18BEA-610E-C84A-9896-74B1099551D5}" type="datetimeFigureOut">
              <a:rPr lang="nl-NL" smtClean="0"/>
              <a:t>20-06-21</a:t>
            </a:fld>
            <a:endParaRPr lang="nl-NL" dirty="0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37E4B-4F1E-3043-A89A-4B5794CD3DCA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73673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 smtClean="0"/>
              <a:t>Titelstijl van model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tekststijl van het model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 smtClean="0"/>
              <a:t>Klik om de tekststijl van het model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tekststijl van het model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 smtClean="0"/>
              <a:t>Klik om de tekststijl van het model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18BEA-610E-C84A-9896-74B1099551D5}" type="datetimeFigureOut">
              <a:rPr lang="nl-NL" smtClean="0"/>
              <a:t>20-06-21</a:t>
            </a:fld>
            <a:endParaRPr lang="nl-NL" dirty="0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37E4B-4F1E-3043-A89A-4B5794CD3DCA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4918515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Titelstijl van model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18BEA-610E-C84A-9896-74B1099551D5}" type="datetimeFigureOut">
              <a:rPr lang="nl-NL" smtClean="0"/>
              <a:t>20-06-21</a:t>
            </a:fld>
            <a:endParaRPr lang="nl-NL" dirty="0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37E4B-4F1E-3043-A89A-4B5794CD3DCA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884174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18BEA-610E-C84A-9896-74B1099551D5}" type="datetimeFigureOut">
              <a:rPr lang="nl-NL" smtClean="0"/>
              <a:t>20-06-21</a:t>
            </a:fld>
            <a:endParaRPr lang="nl-NL" dirty="0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37E4B-4F1E-3043-A89A-4B5794CD3DCA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8837368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 smtClean="0"/>
              <a:t>Titelstijl van model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tekststijl van het model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 smtClean="0"/>
              <a:t>Klik om de tekststijl van het model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18BEA-610E-C84A-9896-74B1099551D5}" type="datetimeFigureOut">
              <a:rPr lang="nl-NL" smtClean="0"/>
              <a:t>20-06-21</a:t>
            </a:fld>
            <a:endParaRPr lang="nl-NL" dirty="0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37E4B-4F1E-3043-A89A-4B5794CD3DCA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7613474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 smtClean="0"/>
              <a:t>Titelstijl van model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 dirty="0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 smtClean="0"/>
              <a:t>Klik om de tekststijl van het model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18BEA-610E-C84A-9896-74B1099551D5}" type="datetimeFigureOut">
              <a:rPr lang="nl-NL" smtClean="0"/>
              <a:t>20-06-21</a:t>
            </a:fld>
            <a:endParaRPr lang="nl-NL" dirty="0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37E4B-4F1E-3043-A89A-4B5794CD3DCA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0526741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Titelstijl van model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tekststijl van het model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618BEA-610E-C84A-9896-74B1099551D5}" type="datetimeFigureOut">
              <a:rPr lang="nl-NL" smtClean="0"/>
              <a:t>20-06-21</a:t>
            </a:fld>
            <a:endParaRPr lang="nl-NL" dirty="0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 dirty="0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137E4B-4F1E-3043-A89A-4B5794CD3DCA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5762809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Relationship Id="rId3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ijdelijke aanduiding voor inhoud 2"/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1019175"/>
          </a:xfrm>
        </p:spPr>
        <p:txBody>
          <a:bodyPr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nl-NL" dirty="0" smtClean="0"/>
              <a:t>No-ACT, unpruned</a:t>
            </a:r>
            <a:endParaRPr lang="nl-NL" dirty="0"/>
          </a:p>
        </p:txBody>
      </p:sp>
      <p:pic>
        <p:nvPicPr>
          <p:cNvPr id="53" name="Afbeelding 5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3000" y="228600"/>
            <a:ext cx="7239000" cy="6629400"/>
          </a:xfrm>
          <a:prstGeom prst="rect">
            <a:avLst/>
          </a:prstGeom>
        </p:spPr>
      </p:pic>
      <p:sp>
        <p:nvSpPr>
          <p:cNvPr id="51" name="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/>
          <a:lstStyle/>
          <a:p>
            <a:r>
              <a:rPr lang="nl-NL" dirty="0" smtClean="0"/>
              <a:t>Supplementary Figure </a:t>
            </a:r>
            <a:r>
              <a:rPr lang="nl-NL" dirty="0"/>
              <a:t>1</a:t>
            </a:r>
            <a:endParaRPr lang="nl-NL" dirty="0">
              <a:solidFill>
                <a:srgbClr val="FF0000"/>
              </a:solidFill>
            </a:endParaRPr>
          </a:p>
        </p:txBody>
      </p:sp>
      <p:sp>
        <p:nvSpPr>
          <p:cNvPr id="5" name="Tijdelijke aanduiding voor inhoud 2"/>
          <p:cNvSpPr txBox="1">
            <a:spLocks/>
          </p:cNvSpPr>
          <p:nvPr/>
        </p:nvSpPr>
        <p:spPr>
          <a:xfrm>
            <a:off x="114300" y="5788025"/>
            <a:ext cx="3987800" cy="132397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800" i="1" u="sng" dirty="0" smtClean="0"/>
              <a:t>Supplementary figure 1:</a:t>
            </a:r>
          </a:p>
          <a:p>
            <a:pPr marL="0" indent="0">
              <a:buNone/>
            </a:pPr>
            <a:r>
              <a:rPr lang="en-GB" sz="1800" i="1" dirty="0" smtClean="0"/>
              <a:t>Unpruned classification tree by CART analysis for ACT-untreated patients. </a:t>
            </a:r>
            <a:endParaRPr lang="en-GB" sz="1800" i="1" dirty="0"/>
          </a:p>
        </p:txBody>
      </p:sp>
    </p:spTree>
    <p:extLst>
      <p:ext uri="{BB962C8B-B14F-4D97-AF65-F5344CB8AC3E}">
        <p14:creationId xmlns:p14="http://schemas.microsoft.com/office/powerpoint/2010/main" val="7949090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 smtClean="0"/>
              <a:t>Supplementary Figure </a:t>
            </a:r>
            <a:r>
              <a:rPr lang="nl-NL" dirty="0"/>
              <a:t>2</a:t>
            </a:r>
            <a:endParaRPr lang="nl-NL" dirty="0">
              <a:solidFill>
                <a:srgbClr val="FF0000"/>
              </a:solidFill>
            </a:endParaRP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nl-NL" dirty="0" smtClean="0"/>
              <a:t>ACT, unpruned</a:t>
            </a:r>
            <a:endParaRPr lang="nl-NL" dirty="0"/>
          </a:p>
        </p:txBody>
      </p:sp>
      <p:pic>
        <p:nvPicPr>
          <p:cNvPr id="4" name="Afbeelding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0100" y="1292225"/>
            <a:ext cx="6172200" cy="4267200"/>
          </a:xfrm>
          <a:prstGeom prst="rect">
            <a:avLst/>
          </a:prstGeom>
        </p:spPr>
      </p:pic>
      <p:sp>
        <p:nvSpPr>
          <p:cNvPr id="5" name="Tijdelijke aanduiding voor inhoud 2"/>
          <p:cNvSpPr txBox="1">
            <a:spLocks/>
          </p:cNvSpPr>
          <p:nvPr/>
        </p:nvSpPr>
        <p:spPr>
          <a:xfrm>
            <a:off x="114300" y="5800725"/>
            <a:ext cx="3987800" cy="132397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800" i="1" u="sng" dirty="0" smtClean="0"/>
              <a:t>Supplementary figure 2:</a:t>
            </a:r>
          </a:p>
          <a:p>
            <a:pPr marL="0" indent="0">
              <a:buNone/>
            </a:pPr>
            <a:r>
              <a:rPr lang="en-GB" sz="1800" i="1" dirty="0" smtClean="0"/>
              <a:t>Unpruned classification tree by CART analysis for ACT-treated patients. </a:t>
            </a:r>
            <a:endParaRPr lang="en-GB" sz="1800" i="1" dirty="0"/>
          </a:p>
        </p:txBody>
      </p:sp>
    </p:spTree>
    <p:extLst>
      <p:ext uri="{BB962C8B-B14F-4D97-AF65-F5344CB8AC3E}">
        <p14:creationId xmlns:p14="http://schemas.microsoft.com/office/powerpoint/2010/main" val="5399294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/>
              <a:t>Supplementary Figure 3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nl-NL" dirty="0" smtClean="0"/>
              <a:t>No-ACT					ACT</a:t>
            </a:r>
            <a:endParaRPr lang="nl-NL" dirty="0"/>
          </a:p>
        </p:txBody>
      </p:sp>
      <p:grpSp>
        <p:nvGrpSpPr>
          <p:cNvPr id="5" name="Groeperen 4"/>
          <p:cNvGrpSpPr/>
          <p:nvPr/>
        </p:nvGrpSpPr>
        <p:grpSpPr>
          <a:xfrm>
            <a:off x="2237501" y="1825625"/>
            <a:ext cx="3941624" cy="3938066"/>
            <a:chOff x="2237501" y="1825625"/>
            <a:chExt cx="3941624" cy="3938066"/>
          </a:xfrm>
        </p:grpSpPr>
        <p:pic>
          <p:nvPicPr>
            <p:cNvPr id="8" name="Afbeelding 7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347"/>
            <a:stretch/>
          </p:blipFill>
          <p:spPr>
            <a:xfrm>
              <a:off x="2838203" y="1825625"/>
              <a:ext cx="3340922" cy="3938066"/>
            </a:xfrm>
            <a:prstGeom prst="rect">
              <a:avLst/>
            </a:prstGeom>
          </p:spPr>
        </p:pic>
        <p:sp>
          <p:nvSpPr>
            <p:cNvPr id="4" name="Tekstvak 3"/>
            <p:cNvSpPr txBox="1"/>
            <p:nvPr/>
          </p:nvSpPr>
          <p:spPr>
            <a:xfrm>
              <a:off x="2237501" y="1825625"/>
              <a:ext cx="736270" cy="35559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KCNQ1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P53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Lamin AC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N-stage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LVI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BCLX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P21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ITD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Emergency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FAS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EGFR (membr)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CD44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Perforation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Stage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Right-sided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T-stage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MIB1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FasL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MacroD2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Mucinous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ACT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CDX2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Aurka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CyclinD1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EGFR (cytopl)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HER2NEU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VEGFA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XIAP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MSI-status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cFLIP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betaCat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P27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HTR2B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Ulceration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BAX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Sex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TS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Age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Bcl2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LUM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Differentiation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VCAN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HIF1a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Tumourspill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Diameter</a:t>
              </a:r>
              <a:endParaRPr lang="en-GB" sz="600" b="1" dirty="0" smtClean="0"/>
            </a:p>
          </p:txBody>
        </p:sp>
      </p:grpSp>
      <p:grpSp>
        <p:nvGrpSpPr>
          <p:cNvPr id="10" name="Groeperen 9"/>
          <p:cNvGrpSpPr/>
          <p:nvPr/>
        </p:nvGrpSpPr>
        <p:grpSpPr>
          <a:xfrm>
            <a:off x="7137832" y="1825625"/>
            <a:ext cx="3943516" cy="3938066"/>
            <a:chOff x="7137832" y="1825625"/>
            <a:chExt cx="3943516" cy="3938066"/>
          </a:xfrm>
        </p:grpSpPr>
        <p:pic>
          <p:nvPicPr>
            <p:cNvPr id="6" name="Afbeelding 5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850"/>
            <a:stretch/>
          </p:blipFill>
          <p:spPr>
            <a:xfrm>
              <a:off x="7772400" y="1825625"/>
              <a:ext cx="3308948" cy="3938066"/>
            </a:xfrm>
            <a:prstGeom prst="rect">
              <a:avLst/>
            </a:prstGeom>
          </p:spPr>
        </p:pic>
        <p:sp>
          <p:nvSpPr>
            <p:cNvPr id="9" name="Tekstvak 8"/>
            <p:cNvSpPr txBox="1"/>
            <p:nvPr/>
          </p:nvSpPr>
          <p:spPr>
            <a:xfrm>
              <a:off x="7137832" y="1825625"/>
              <a:ext cx="736270" cy="355481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KCNQ1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LVI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MacroD2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P27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Emergency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Bcl2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Right-sided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BAX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HER2NEU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VEGFA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Perforation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MIB1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Stage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Aurka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EGFR (cytopl)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Mucinous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ACT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Tumourspill</a:t>
              </a:r>
              <a:endParaRPr lang="en-GB" sz="600" b="1" dirty="0" smtClean="0"/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MSI-status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Differentation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EGFR (membr)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ITD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P21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Sex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FasL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Ulceration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XIAP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P53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HTR2B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TS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CDX2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BCLX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T-stage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Hif1a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CyclinD1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CD44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BetaCat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LUM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Lamin AC</a:t>
              </a:r>
              <a:endParaRPr lang="en-GB" sz="600" b="1" dirty="0" smtClean="0"/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VCAN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cFLIP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FAS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Diameter</a:t>
              </a:r>
            </a:p>
            <a:p>
              <a:pPr algn="r">
                <a:lnSpc>
                  <a:spcPts val="550"/>
                </a:lnSpc>
              </a:pPr>
              <a:r>
                <a:rPr lang="en-GB" sz="600" b="1" dirty="0" smtClean="0"/>
                <a:t>Age</a:t>
              </a:r>
              <a:endParaRPr lang="en-GB" sz="600" b="1" dirty="0" smtClean="0"/>
            </a:p>
          </p:txBody>
        </p:sp>
      </p:grpSp>
      <p:sp>
        <p:nvSpPr>
          <p:cNvPr id="11" name="Tijdelijke aanduiding voor inhoud 2"/>
          <p:cNvSpPr txBox="1">
            <a:spLocks/>
          </p:cNvSpPr>
          <p:nvPr/>
        </p:nvSpPr>
        <p:spPr>
          <a:xfrm>
            <a:off x="114300" y="5788025"/>
            <a:ext cx="11239500" cy="132397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800" i="1" u="sng" dirty="0" smtClean="0"/>
              <a:t>Supplementary figure 3:</a:t>
            </a:r>
          </a:p>
          <a:p>
            <a:pPr marL="0" indent="0">
              <a:buNone/>
            </a:pPr>
            <a:r>
              <a:rPr lang="en-GB" sz="1800" i="1" dirty="0" smtClean="0"/>
              <a:t>Variable importance graphs for both ACT-untreated and -treated </a:t>
            </a:r>
            <a:r>
              <a:rPr lang="en-GB" sz="1800" i="1" dirty="0" smtClean="0"/>
              <a:t>patients. </a:t>
            </a:r>
            <a:r>
              <a:rPr lang="en-GB" sz="1200" i="1" dirty="0" smtClean="0"/>
              <a:t>LVI = lymphovascular invasion / ITD = isolated tumour deposits / Emergency = emergency surgery / ACT = adjuvant chemotherapy.</a:t>
            </a:r>
            <a:endParaRPr lang="en-GB" sz="1800" i="1" dirty="0" smtClean="0"/>
          </a:p>
        </p:txBody>
      </p:sp>
    </p:spTree>
    <p:extLst>
      <p:ext uri="{BB962C8B-B14F-4D97-AF65-F5344CB8AC3E}">
        <p14:creationId xmlns:p14="http://schemas.microsoft.com/office/powerpoint/2010/main" val="3998784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3</TotalTime>
  <Words>183</Words>
  <Application>Microsoft Macintosh PowerPoint</Application>
  <PresentationFormat>Breedbeeld</PresentationFormat>
  <Paragraphs>101</Paragraphs>
  <Slides>3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3</vt:i4>
      </vt:variant>
    </vt:vector>
  </HeadingPairs>
  <TitlesOfParts>
    <vt:vector size="7" baseType="lpstr">
      <vt:lpstr>Calibri</vt:lpstr>
      <vt:lpstr>Calibri Light</vt:lpstr>
      <vt:lpstr>Arial</vt:lpstr>
      <vt:lpstr>Office-thema</vt:lpstr>
      <vt:lpstr>Supplementary Figure 1</vt:lpstr>
      <vt:lpstr>Supplementary Figure 2</vt:lpstr>
      <vt:lpstr>Supplementary Figure 3</vt:lpstr>
    </vt:vector>
  </TitlesOfParts>
  <Company/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1a</dc:title>
  <dc:creator>Sjoerd den Uil</dc:creator>
  <cp:lastModifiedBy>Sjoerd den Uil</cp:lastModifiedBy>
  <cp:revision>44</cp:revision>
  <dcterms:created xsi:type="dcterms:W3CDTF">2020-12-11T15:09:54Z</dcterms:created>
  <dcterms:modified xsi:type="dcterms:W3CDTF">2021-06-20T12:32:29Z</dcterms:modified>
</cp:coreProperties>
</file>